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52" d="100"/>
          <a:sy n="52" d="100"/>
        </p:scale>
        <p:origin x="231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31F811-B005-4A02-902A-9738D518A43C}" type="datetimeFigureOut">
              <a:rPr lang="en-US" smtClean="0"/>
              <a:t>10/3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07CE5-A97E-441F-AF3F-C71DBB0708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45742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31F811-B005-4A02-902A-9738D518A43C}" type="datetimeFigureOut">
              <a:rPr lang="en-US" smtClean="0"/>
              <a:t>10/3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07CE5-A97E-441F-AF3F-C71DBB0708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86330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31F811-B005-4A02-902A-9738D518A43C}" type="datetimeFigureOut">
              <a:rPr lang="en-US" smtClean="0"/>
              <a:t>10/3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07CE5-A97E-441F-AF3F-C71DBB0708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54283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31F811-B005-4A02-902A-9738D518A43C}" type="datetimeFigureOut">
              <a:rPr lang="en-US" smtClean="0"/>
              <a:t>10/3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07CE5-A97E-441F-AF3F-C71DBB0708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01936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31F811-B005-4A02-902A-9738D518A43C}" type="datetimeFigureOut">
              <a:rPr lang="en-US" smtClean="0"/>
              <a:t>10/3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07CE5-A97E-441F-AF3F-C71DBB0708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9630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31F811-B005-4A02-902A-9738D518A43C}" type="datetimeFigureOut">
              <a:rPr lang="en-US" smtClean="0"/>
              <a:t>10/30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07CE5-A97E-441F-AF3F-C71DBB0708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17148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31F811-B005-4A02-902A-9738D518A43C}" type="datetimeFigureOut">
              <a:rPr lang="en-US" smtClean="0"/>
              <a:t>10/30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07CE5-A97E-441F-AF3F-C71DBB0708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27965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31F811-B005-4A02-902A-9738D518A43C}" type="datetimeFigureOut">
              <a:rPr lang="en-US" smtClean="0"/>
              <a:t>10/30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07CE5-A97E-441F-AF3F-C71DBB0708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8724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31F811-B005-4A02-902A-9738D518A43C}" type="datetimeFigureOut">
              <a:rPr lang="en-US" smtClean="0"/>
              <a:t>10/30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07CE5-A97E-441F-AF3F-C71DBB0708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32460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31F811-B005-4A02-902A-9738D518A43C}" type="datetimeFigureOut">
              <a:rPr lang="en-US" smtClean="0"/>
              <a:t>10/30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07CE5-A97E-441F-AF3F-C71DBB0708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65964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31F811-B005-4A02-902A-9738D518A43C}" type="datetimeFigureOut">
              <a:rPr lang="en-US" smtClean="0"/>
              <a:t>10/30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07CE5-A97E-441F-AF3F-C71DBB0708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70522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31F811-B005-4A02-902A-9738D518A43C}" type="datetimeFigureOut">
              <a:rPr lang="en-US" smtClean="0"/>
              <a:t>10/3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E07CE5-A97E-441F-AF3F-C71DBB0708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4799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1389" y="1801790"/>
            <a:ext cx="6447088" cy="6069329"/>
          </a:xfrm>
          <a:prstGeom prst="rect">
            <a:avLst/>
          </a:prstGeom>
        </p:spPr>
      </p:pic>
      <p:sp>
        <p:nvSpPr>
          <p:cNvPr id="2" name="Rectangle 1"/>
          <p:cNvSpPr/>
          <p:nvPr/>
        </p:nvSpPr>
        <p:spPr>
          <a:xfrm>
            <a:off x="374944" y="917643"/>
            <a:ext cx="603997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dditional file 1: Figure S1. Map of Uganda showing the various districts from which tick samples were </a:t>
            </a:r>
            <a:r>
              <a:rPr lang="en-US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llected.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" name="Rectangle 2"/>
          <p:cNvSpPr/>
          <p:nvPr/>
        </p:nvSpPr>
        <p:spPr>
          <a:xfrm>
            <a:off x="337622" y="8108935"/>
            <a:ext cx="603997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Map of Africa showing Uganda. 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Map of Uganda showing the areas from which ticks were collected (depicted by ticks).</a:t>
            </a:r>
            <a:endParaRPr lang="en-US" sz="16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528225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47</Words>
  <Application>Microsoft Office PowerPoint</Application>
  <PresentationFormat>A4 Paper (210x297 mm)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HP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P</dc:creator>
  <cp:lastModifiedBy>VP</cp:lastModifiedBy>
  <cp:revision>4</cp:revision>
  <dcterms:created xsi:type="dcterms:W3CDTF">2015-08-25T04:59:49Z</dcterms:created>
  <dcterms:modified xsi:type="dcterms:W3CDTF">2015-10-30T14:50:20Z</dcterms:modified>
</cp:coreProperties>
</file>